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3"/>
  </p:notesMasterIdLst>
  <p:sldIdLst>
    <p:sldId id="283" r:id="rId2"/>
  </p:sldIdLst>
  <p:sldSz cx="612616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578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3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B32A65-C63A-425F-86CF-1B961B7C8144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51050" y="1143000"/>
            <a:ext cx="2755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02B05C-6FCC-4C4D-B55C-773DA0C3B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608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40486" rtl="0" eaLnBrk="1" latinLnBrk="0" hangingPunct="1">
      <a:defRPr sz="1103" kern="1200">
        <a:solidFill>
          <a:schemeClr val="tx1"/>
        </a:solidFill>
        <a:latin typeface="+mn-lt"/>
        <a:ea typeface="+mn-ea"/>
        <a:cs typeface="+mn-cs"/>
      </a:defRPr>
    </a:lvl1pPr>
    <a:lvl2pPr marL="420242" algn="l" defTabSz="840486" rtl="0" eaLnBrk="1" latinLnBrk="0" hangingPunct="1">
      <a:defRPr sz="1103" kern="1200">
        <a:solidFill>
          <a:schemeClr val="tx1"/>
        </a:solidFill>
        <a:latin typeface="+mn-lt"/>
        <a:ea typeface="+mn-ea"/>
        <a:cs typeface="+mn-cs"/>
      </a:defRPr>
    </a:lvl2pPr>
    <a:lvl3pPr marL="840486" algn="l" defTabSz="840486" rtl="0" eaLnBrk="1" latinLnBrk="0" hangingPunct="1">
      <a:defRPr sz="1103" kern="1200">
        <a:solidFill>
          <a:schemeClr val="tx1"/>
        </a:solidFill>
        <a:latin typeface="+mn-lt"/>
        <a:ea typeface="+mn-ea"/>
        <a:cs typeface="+mn-cs"/>
      </a:defRPr>
    </a:lvl3pPr>
    <a:lvl4pPr marL="1260728" algn="l" defTabSz="840486" rtl="0" eaLnBrk="1" latinLnBrk="0" hangingPunct="1">
      <a:defRPr sz="1103" kern="1200">
        <a:solidFill>
          <a:schemeClr val="tx1"/>
        </a:solidFill>
        <a:latin typeface="+mn-lt"/>
        <a:ea typeface="+mn-ea"/>
        <a:cs typeface="+mn-cs"/>
      </a:defRPr>
    </a:lvl4pPr>
    <a:lvl5pPr marL="1680971" algn="l" defTabSz="840486" rtl="0" eaLnBrk="1" latinLnBrk="0" hangingPunct="1">
      <a:defRPr sz="1103" kern="1200">
        <a:solidFill>
          <a:schemeClr val="tx1"/>
        </a:solidFill>
        <a:latin typeface="+mn-lt"/>
        <a:ea typeface="+mn-ea"/>
        <a:cs typeface="+mn-cs"/>
      </a:defRPr>
    </a:lvl5pPr>
    <a:lvl6pPr marL="2101214" algn="l" defTabSz="840486" rtl="0" eaLnBrk="1" latinLnBrk="0" hangingPunct="1">
      <a:defRPr sz="1103" kern="1200">
        <a:solidFill>
          <a:schemeClr val="tx1"/>
        </a:solidFill>
        <a:latin typeface="+mn-lt"/>
        <a:ea typeface="+mn-ea"/>
        <a:cs typeface="+mn-cs"/>
      </a:defRPr>
    </a:lvl6pPr>
    <a:lvl7pPr marL="2521457" algn="l" defTabSz="840486" rtl="0" eaLnBrk="1" latinLnBrk="0" hangingPunct="1">
      <a:defRPr sz="1103" kern="1200">
        <a:solidFill>
          <a:schemeClr val="tx1"/>
        </a:solidFill>
        <a:latin typeface="+mn-lt"/>
        <a:ea typeface="+mn-ea"/>
        <a:cs typeface="+mn-cs"/>
      </a:defRPr>
    </a:lvl7pPr>
    <a:lvl8pPr marL="2941699" algn="l" defTabSz="840486" rtl="0" eaLnBrk="1" latinLnBrk="0" hangingPunct="1">
      <a:defRPr sz="1103" kern="1200">
        <a:solidFill>
          <a:schemeClr val="tx1"/>
        </a:solidFill>
        <a:latin typeface="+mn-lt"/>
        <a:ea typeface="+mn-ea"/>
        <a:cs typeface="+mn-cs"/>
      </a:defRPr>
    </a:lvl8pPr>
    <a:lvl9pPr marL="3361943" algn="l" defTabSz="840486" rtl="0" eaLnBrk="1" latinLnBrk="0" hangingPunct="1">
      <a:defRPr sz="110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9464" y="1122363"/>
            <a:ext cx="5207239" cy="2387600"/>
          </a:xfrm>
        </p:spPr>
        <p:txBody>
          <a:bodyPr anchor="b"/>
          <a:lstStyle>
            <a:lvl1pPr algn="ctr">
              <a:defRPr sz="40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5771" y="3602038"/>
            <a:ext cx="4594622" cy="1655762"/>
          </a:xfrm>
        </p:spPr>
        <p:txBody>
          <a:bodyPr/>
          <a:lstStyle>
            <a:lvl1pPr marL="0" indent="0" algn="ctr">
              <a:buNone/>
              <a:defRPr sz="1608"/>
            </a:lvl1pPr>
            <a:lvl2pPr marL="306324" indent="0" algn="ctr">
              <a:buNone/>
              <a:defRPr sz="1340"/>
            </a:lvl2pPr>
            <a:lvl3pPr marL="612648" indent="0" algn="ctr">
              <a:buNone/>
              <a:defRPr sz="1206"/>
            </a:lvl3pPr>
            <a:lvl4pPr marL="918972" indent="0" algn="ctr">
              <a:buNone/>
              <a:defRPr sz="1072"/>
            </a:lvl4pPr>
            <a:lvl5pPr marL="1225296" indent="0" algn="ctr">
              <a:buNone/>
              <a:defRPr sz="1072"/>
            </a:lvl5pPr>
            <a:lvl6pPr marL="1531620" indent="0" algn="ctr">
              <a:buNone/>
              <a:defRPr sz="1072"/>
            </a:lvl6pPr>
            <a:lvl7pPr marL="1837944" indent="0" algn="ctr">
              <a:buNone/>
              <a:defRPr sz="1072"/>
            </a:lvl7pPr>
            <a:lvl8pPr marL="2144268" indent="0" algn="ctr">
              <a:buNone/>
              <a:defRPr sz="1072"/>
            </a:lvl8pPr>
            <a:lvl9pPr marL="2450592" indent="0" algn="ctr">
              <a:buNone/>
              <a:defRPr sz="1072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230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400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84036" y="365125"/>
            <a:ext cx="1320954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1176" y="365125"/>
            <a:ext cx="388628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617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081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983" y="1709740"/>
            <a:ext cx="5283816" cy="2852737"/>
          </a:xfrm>
        </p:spPr>
        <p:txBody>
          <a:bodyPr anchor="b"/>
          <a:lstStyle>
            <a:lvl1pPr>
              <a:defRPr sz="40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983" y="4589466"/>
            <a:ext cx="5283816" cy="1500187"/>
          </a:xfrm>
        </p:spPr>
        <p:txBody>
          <a:bodyPr/>
          <a:lstStyle>
            <a:lvl1pPr marL="0" indent="0">
              <a:buNone/>
              <a:defRPr sz="1608">
                <a:solidFill>
                  <a:schemeClr val="tx1"/>
                </a:solidFill>
              </a:defRPr>
            </a:lvl1pPr>
            <a:lvl2pPr marL="306324" indent="0">
              <a:buNone/>
              <a:defRPr sz="1340">
                <a:solidFill>
                  <a:schemeClr val="tx1">
                    <a:tint val="75000"/>
                  </a:schemeClr>
                </a:solidFill>
              </a:defRPr>
            </a:lvl2pPr>
            <a:lvl3pPr marL="612648" indent="0">
              <a:buNone/>
              <a:defRPr sz="1206">
                <a:solidFill>
                  <a:schemeClr val="tx1">
                    <a:tint val="75000"/>
                  </a:schemeClr>
                </a:solidFill>
              </a:defRPr>
            </a:lvl3pPr>
            <a:lvl4pPr marL="918972" indent="0">
              <a:buNone/>
              <a:defRPr sz="1072">
                <a:solidFill>
                  <a:schemeClr val="tx1">
                    <a:tint val="75000"/>
                  </a:schemeClr>
                </a:solidFill>
              </a:defRPr>
            </a:lvl4pPr>
            <a:lvl5pPr marL="1225296" indent="0">
              <a:buNone/>
              <a:defRPr sz="1072">
                <a:solidFill>
                  <a:schemeClr val="tx1">
                    <a:tint val="75000"/>
                  </a:schemeClr>
                </a:solidFill>
              </a:defRPr>
            </a:lvl5pPr>
            <a:lvl6pPr marL="1531620" indent="0">
              <a:buNone/>
              <a:defRPr sz="1072">
                <a:solidFill>
                  <a:schemeClr val="tx1">
                    <a:tint val="75000"/>
                  </a:schemeClr>
                </a:solidFill>
              </a:defRPr>
            </a:lvl6pPr>
            <a:lvl7pPr marL="1837944" indent="0">
              <a:buNone/>
              <a:defRPr sz="1072">
                <a:solidFill>
                  <a:schemeClr val="tx1">
                    <a:tint val="75000"/>
                  </a:schemeClr>
                </a:solidFill>
              </a:defRPr>
            </a:lvl7pPr>
            <a:lvl8pPr marL="2144268" indent="0">
              <a:buNone/>
              <a:defRPr sz="1072">
                <a:solidFill>
                  <a:schemeClr val="tx1">
                    <a:tint val="75000"/>
                  </a:schemeClr>
                </a:solidFill>
              </a:defRPr>
            </a:lvl8pPr>
            <a:lvl9pPr marL="2450592" indent="0">
              <a:buNone/>
              <a:defRPr sz="107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851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1176" y="1825626"/>
            <a:ext cx="2603619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01372" y="1825626"/>
            <a:ext cx="2603619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852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971" y="365128"/>
            <a:ext cx="5283816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972" y="1681163"/>
            <a:ext cx="2591654" cy="823912"/>
          </a:xfrm>
        </p:spPr>
        <p:txBody>
          <a:bodyPr anchor="b"/>
          <a:lstStyle>
            <a:lvl1pPr marL="0" indent="0">
              <a:buNone/>
              <a:defRPr sz="1608" b="1"/>
            </a:lvl1pPr>
            <a:lvl2pPr marL="306324" indent="0">
              <a:buNone/>
              <a:defRPr sz="1340" b="1"/>
            </a:lvl2pPr>
            <a:lvl3pPr marL="612648" indent="0">
              <a:buNone/>
              <a:defRPr sz="1206" b="1"/>
            </a:lvl3pPr>
            <a:lvl4pPr marL="918972" indent="0">
              <a:buNone/>
              <a:defRPr sz="1072" b="1"/>
            </a:lvl4pPr>
            <a:lvl5pPr marL="1225296" indent="0">
              <a:buNone/>
              <a:defRPr sz="1072" b="1"/>
            </a:lvl5pPr>
            <a:lvl6pPr marL="1531620" indent="0">
              <a:buNone/>
              <a:defRPr sz="1072" b="1"/>
            </a:lvl6pPr>
            <a:lvl7pPr marL="1837944" indent="0">
              <a:buNone/>
              <a:defRPr sz="1072" b="1"/>
            </a:lvl7pPr>
            <a:lvl8pPr marL="2144268" indent="0">
              <a:buNone/>
              <a:defRPr sz="1072" b="1"/>
            </a:lvl8pPr>
            <a:lvl9pPr marL="2450592" indent="0">
              <a:buNone/>
              <a:defRPr sz="1072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972" y="2505076"/>
            <a:ext cx="2591654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1372" y="1681163"/>
            <a:ext cx="2604417" cy="823912"/>
          </a:xfrm>
        </p:spPr>
        <p:txBody>
          <a:bodyPr anchor="b"/>
          <a:lstStyle>
            <a:lvl1pPr marL="0" indent="0">
              <a:buNone/>
              <a:defRPr sz="1608" b="1"/>
            </a:lvl1pPr>
            <a:lvl2pPr marL="306324" indent="0">
              <a:buNone/>
              <a:defRPr sz="1340" b="1"/>
            </a:lvl2pPr>
            <a:lvl3pPr marL="612648" indent="0">
              <a:buNone/>
              <a:defRPr sz="1206" b="1"/>
            </a:lvl3pPr>
            <a:lvl4pPr marL="918972" indent="0">
              <a:buNone/>
              <a:defRPr sz="1072" b="1"/>
            </a:lvl4pPr>
            <a:lvl5pPr marL="1225296" indent="0">
              <a:buNone/>
              <a:defRPr sz="1072" b="1"/>
            </a:lvl5pPr>
            <a:lvl6pPr marL="1531620" indent="0">
              <a:buNone/>
              <a:defRPr sz="1072" b="1"/>
            </a:lvl6pPr>
            <a:lvl7pPr marL="1837944" indent="0">
              <a:buNone/>
              <a:defRPr sz="1072" b="1"/>
            </a:lvl7pPr>
            <a:lvl8pPr marL="2144268" indent="0">
              <a:buNone/>
              <a:defRPr sz="1072" b="1"/>
            </a:lvl8pPr>
            <a:lvl9pPr marL="2450592" indent="0">
              <a:buNone/>
              <a:defRPr sz="1072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1372" y="2505076"/>
            <a:ext cx="260441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371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186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834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974" y="457200"/>
            <a:ext cx="1975847" cy="1600200"/>
          </a:xfrm>
        </p:spPr>
        <p:txBody>
          <a:bodyPr anchor="b"/>
          <a:lstStyle>
            <a:lvl1pPr>
              <a:defRPr sz="214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4417" y="987428"/>
            <a:ext cx="3101370" cy="4873625"/>
          </a:xfrm>
        </p:spPr>
        <p:txBody>
          <a:bodyPr/>
          <a:lstStyle>
            <a:lvl1pPr>
              <a:defRPr sz="2144"/>
            </a:lvl1pPr>
            <a:lvl2pPr>
              <a:defRPr sz="1876"/>
            </a:lvl2pPr>
            <a:lvl3pPr>
              <a:defRPr sz="1608"/>
            </a:lvl3pPr>
            <a:lvl4pPr>
              <a:defRPr sz="1340"/>
            </a:lvl4pPr>
            <a:lvl5pPr>
              <a:defRPr sz="1340"/>
            </a:lvl5pPr>
            <a:lvl6pPr>
              <a:defRPr sz="1340"/>
            </a:lvl6pPr>
            <a:lvl7pPr>
              <a:defRPr sz="1340"/>
            </a:lvl7pPr>
            <a:lvl8pPr>
              <a:defRPr sz="1340"/>
            </a:lvl8pPr>
            <a:lvl9pPr>
              <a:defRPr sz="134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974" y="2057400"/>
            <a:ext cx="1975847" cy="3811588"/>
          </a:xfrm>
        </p:spPr>
        <p:txBody>
          <a:bodyPr/>
          <a:lstStyle>
            <a:lvl1pPr marL="0" indent="0">
              <a:buNone/>
              <a:defRPr sz="1072"/>
            </a:lvl1pPr>
            <a:lvl2pPr marL="306324" indent="0">
              <a:buNone/>
              <a:defRPr sz="938"/>
            </a:lvl2pPr>
            <a:lvl3pPr marL="612648" indent="0">
              <a:buNone/>
              <a:defRPr sz="804"/>
            </a:lvl3pPr>
            <a:lvl4pPr marL="918972" indent="0">
              <a:buNone/>
              <a:defRPr sz="670"/>
            </a:lvl4pPr>
            <a:lvl5pPr marL="1225296" indent="0">
              <a:buNone/>
              <a:defRPr sz="670"/>
            </a:lvl5pPr>
            <a:lvl6pPr marL="1531620" indent="0">
              <a:buNone/>
              <a:defRPr sz="670"/>
            </a:lvl6pPr>
            <a:lvl7pPr marL="1837944" indent="0">
              <a:buNone/>
              <a:defRPr sz="670"/>
            </a:lvl7pPr>
            <a:lvl8pPr marL="2144268" indent="0">
              <a:buNone/>
              <a:defRPr sz="670"/>
            </a:lvl8pPr>
            <a:lvl9pPr marL="2450592" indent="0">
              <a:buNone/>
              <a:defRPr sz="67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139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974" y="457200"/>
            <a:ext cx="1975847" cy="1600200"/>
          </a:xfrm>
        </p:spPr>
        <p:txBody>
          <a:bodyPr anchor="b"/>
          <a:lstStyle>
            <a:lvl1pPr>
              <a:defRPr sz="214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4417" y="987428"/>
            <a:ext cx="3101370" cy="4873625"/>
          </a:xfrm>
        </p:spPr>
        <p:txBody>
          <a:bodyPr anchor="t"/>
          <a:lstStyle>
            <a:lvl1pPr marL="0" indent="0">
              <a:buNone/>
              <a:defRPr sz="2144"/>
            </a:lvl1pPr>
            <a:lvl2pPr marL="306324" indent="0">
              <a:buNone/>
              <a:defRPr sz="1876"/>
            </a:lvl2pPr>
            <a:lvl3pPr marL="612648" indent="0">
              <a:buNone/>
              <a:defRPr sz="1608"/>
            </a:lvl3pPr>
            <a:lvl4pPr marL="918972" indent="0">
              <a:buNone/>
              <a:defRPr sz="1340"/>
            </a:lvl4pPr>
            <a:lvl5pPr marL="1225296" indent="0">
              <a:buNone/>
              <a:defRPr sz="1340"/>
            </a:lvl5pPr>
            <a:lvl6pPr marL="1531620" indent="0">
              <a:buNone/>
              <a:defRPr sz="1340"/>
            </a:lvl6pPr>
            <a:lvl7pPr marL="1837944" indent="0">
              <a:buNone/>
              <a:defRPr sz="1340"/>
            </a:lvl7pPr>
            <a:lvl8pPr marL="2144268" indent="0">
              <a:buNone/>
              <a:defRPr sz="1340"/>
            </a:lvl8pPr>
            <a:lvl9pPr marL="2450592" indent="0">
              <a:buNone/>
              <a:defRPr sz="134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974" y="2057400"/>
            <a:ext cx="1975847" cy="3811588"/>
          </a:xfrm>
        </p:spPr>
        <p:txBody>
          <a:bodyPr/>
          <a:lstStyle>
            <a:lvl1pPr marL="0" indent="0">
              <a:buNone/>
              <a:defRPr sz="1072"/>
            </a:lvl1pPr>
            <a:lvl2pPr marL="306324" indent="0">
              <a:buNone/>
              <a:defRPr sz="938"/>
            </a:lvl2pPr>
            <a:lvl3pPr marL="612648" indent="0">
              <a:buNone/>
              <a:defRPr sz="804"/>
            </a:lvl3pPr>
            <a:lvl4pPr marL="918972" indent="0">
              <a:buNone/>
              <a:defRPr sz="670"/>
            </a:lvl4pPr>
            <a:lvl5pPr marL="1225296" indent="0">
              <a:buNone/>
              <a:defRPr sz="670"/>
            </a:lvl5pPr>
            <a:lvl6pPr marL="1531620" indent="0">
              <a:buNone/>
              <a:defRPr sz="670"/>
            </a:lvl6pPr>
            <a:lvl7pPr marL="1837944" indent="0">
              <a:buNone/>
              <a:defRPr sz="670"/>
            </a:lvl7pPr>
            <a:lvl8pPr marL="2144268" indent="0">
              <a:buNone/>
              <a:defRPr sz="670"/>
            </a:lvl8pPr>
            <a:lvl9pPr marL="2450592" indent="0">
              <a:buNone/>
              <a:defRPr sz="67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538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1174" y="365128"/>
            <a:ext cx="528381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174" y="1825626"/>
            <a:ext cx="5283816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1176" y="6356353"/>
            <a:ext cx="137838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394CB-383E-4184-A89A-0ED5C8537D09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9292" y="6356353"/>
            <a:ext cx="20675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6604" y="6356353"/>
            <a:ext cx="137838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DA9FE-5791-4D9A-871E-C71D09735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44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12648" rtl="0" eaLnBrk="1" latinLnBrk="0" hangingPunct="1">
        <a:lnSpc>
          <a:spcPct val="90000"/>
        </a:lnSpc>
        <a:spcBef>
          <a:spcPct val="0"/>
        </a:spcBef>
        <a:buNone/>
        <a:defRPr sz="294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162" indent="-153162" algn="l" defTabSz="612648" rtl="0" eaLnBrk="1" latinLnBrk="0" hangingPunct="1">
        <a:lnSpc>
          <a:spcPct val="90000"/>
        </a:lnSpc>
        <a:spcBef>
          <a:spcPts val="670"/>
        </a:spcBef>
        <a:buFont typeface="Arial" panose="020B0604020202020204" pitchFamily="34" charset="0"/>
        <a:buChar char="•"/>
        <a:defRPr sz="1876" kern="1200">
          <a:solidFill>
            <a:schemeClr val="tx1"/>
          </a:solidFill>
          <a:latin typeface="+mn-lt"/>
          <a:ea typeface="+mn-ea"/>
          <a:cs typeface="+mn-cs"/>
        </a:defRPr>
      </a:lvl1pPr>
      <a:lvl2pPr marL="459486" indent="-153162" algn="l" defTabSz="61264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8" kern="1200">
          <a:solidFill>
            <a:schemeClr val="tx1"/>
          </a:solidFill>
          <a:latin typeface="+mn-lt"/>
          <a:ea typeface="+mn-ea"/>
          <a:cs typeface="+mn-cs"/>
        </a:defRPr>
      </a:lvl2pPr>
      <a:lvl3pPr marL="765810" indent="-153162" algn="l" defTabSz="61264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40" kern="1200">
          <a:solidFill>
            <a:schemeClr val="tx1"/>
          </a:solidFill>
          <a:latin typeface="+mn-lt"/>
          <a:ea typeface="+mn-ea"/>
          <a:cs typeface="+mn-cs"/>
        </a:defRPr>
      </a:lvl3pPr>
      <a:lvl4pPr marL="1072134" indent="-153162" algn="l" defTabSz="61264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6" kern="1200">
          <a:solidFill>
            <a:schemeClr val="tx1"/>
          </a:solidFill>
          <a:latin typeface="+mn-lt"/>
          <a:ea typeface="+mn-ea"/>
          <a:cs typeface="+mn-cs"/>
        </a:defRPr>
      </a:lvl4pPr>
      <a:lvl5pPr marL="1378458" indent="-153162" algn="l" defTabSz="61264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6" kern="1200">
          <a:solidFill>
            <a:schemeClr val="tx1"/>
          </a:solidFill>
          <a:latin typeface="+mn-lt"/>
          <a:ea typeface="+mn-ea"/>
          <a:cs typeface="+mn-cs"/>
        </a:defRPr>
      </a:lvl5pPr>
      <a:lvl6pPr marL="1684782" indent="-153162" algn="l" defTabSz="61264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6" kern="1200">
          <a:solidFill>
            <a:schemeClr val="tx1"/>
          </a:solidFill>
          <a:latin typeface="+mn-lt"/>
          <a:ea typeface="+mn-ea"/>
          <a:cs typeface="+mn-cs"/>
        </a:defRPr>
      </a:lvl6pPr>
      <a:lvl7pPr marL="1991106" indent="-153162" algn="l" defTabSz="61264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6" kern="1200">
          <a:solidFill>
            <a:schemeClr val="tx1"/>
          </a:solidFill>
          <a:latin typeface="+mn-lt"/>
          <a:ea typeface="+mn-ea"/>
          <a:cs typeface="+mn-cs"/>
        </a:defRPr>
      </a:lvl7pPr>
      <a:lvl8pPr marL="2297430" indent="-153162" algn="l" defTabSz="61264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6" kern="1200">
          <a:solidFill>
            <a:schemeClr val="tx1"/>
          </a:solidFill>
          <a:latin typeface="+mn-lt"/>
          <a:ea typeface="+mn-ea"/>
          <a:cs typeface="+mn-cs"/>
        </a:defRPr>
      </a:lvl8pPr>
      <a:lvl9pPr marL="2603754" indent="-153162" algn="l" defTabSz="61264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648" rtl="0" eaLnBrk="1" latinLnBrk="0" hangingPunct="1">
        <a:defRPr sz="1206" kern="1200">
          <a:solidFill>
            <a:schemeClr val="tx1"/>
          </a:solidFill>
          <a:latin typeface="+mn-lt"/>
          <a:ea typeface="+mn-ea"/>
          <a:cs typeface="+mn-cs"/>
        </a:defRPr>
      </a:lvl1pPr>
      <a:lvl2pPr marL="306324" algn="l" defTabSz="612648" rtl="0" eaLnBrk="1" latinLnBrk="0" hangingPunct="1">
        <a:defRPr sz="1206" kern="1200">
          <a:solidFill>
            <a:schemeClr val="tx1"/>
          </a:solidFill>
          <a:latin typeface="+mn-lt"/>
          <a:ea typeface="+mn-ea"/>
          <a:cs typeface="+mn-cs"/>
        </a:defRPr>
      </a:lvl2pPr>
      <a:lvl3pPr marL="612648" algn="l" defTabSz="612648" rtl="0" eaLnBrk="1" latinLnBrk="0" hangingPunct="1">
        <a:defRPr sz="1206" kern="1200">
          <a:solidFill>
            <a:schemeClr val="tx1"/>
          </a:solidFill>
          <a:latin typeface="+mn-lt"/>
          <a:ea typeface="+mn-ea"/>
          <a:cs typeface="+mn-cs"/>
        </a:defRPr>
      </a:lvl3pPr>
      <a:lvl4pPr marL="918972" algn="l" defTabSz="612648" rtl="0" eaLnBrk="1" latinLnBrk="0" hangingPunct="1">
        <a:defRPr sz="1206" kern="1200">
          <a:solidFill>
            <a:schemeClr val="tx1"/>
          </a:solidFill>
          <a:latin typeface="+mn-lt"/>
          <a:ea typeface="+mn-ea"/>
          <a:cs typeface="+mn-cs"/>
        </a:defRPr>
      </a:lvl4pPr>
      <a:lvl5pPr marL="1225296" algn="l" defTabSz="612648" rtl="0" eaLnBrk="1" latinLnBrk="0" hangingPunct="1">
        <a:defRPr sz="1206" kern="1200">
          <a:solidFill>
            <a:schemeClr val="tx1"/>
          </a:solidFill>
          <a:latin typeface="+mn-lt"/>
          <a:ea typeface="+mn-ea"/>
          <a:cs typeface="+mn-cs"/>
        </a:defRPr>
      </a:lvl5pPr>
      <a:lvl6pPr marL="1531620" algn="l" defTabSz="612648" rtl="0" eaLnBrk="1" latinLnBrk="0" hangingPunct="1">
        <a:defRPr sz="1206" kern="1200">
          <a:solidFill>
            <a:schemeClr val="tx1"/>
          </a:solidFill>
          <a:latin typeface="+mn-lt"/>
          <a:ea typeface="+mn-ea"/>
          <a:cs typeface="+mn-cs"/>
        </a:defRPr>
      </a:lvl6pPr>
      <a:lvl7pPr marL="1837944" algn="l" defTabSz="612648" rtl="0" eaLnBrk="1" latinLnBrk="0" hangingPunct="1">
        <a:defRPr sz="1206" kern="1200">
          <a:solidFill>
            <a:schemeClr val="tx1"/>
          </a:solidFill>
          <a:latin typeface="+mn-lt"/>
          <a:ea typeface="+mn-ea"/>
          <a:cs typeface="+mn-cs"/>
        </a:defRPr>
      </a:lvl7pPr>
      <a:lvl8pPr marL="2144268" algn="l" defTabSz="612648" rtl="0" eaLnBrk="1" latinLnBrk="0" hangingPunct="1">
        <a:defRPr sz="1206" kern="1200">
          <a:solidFill>
            <a:schemeClr val="tx1"/>
          </a:solidFill>
          <a:latin typeface="+mn-lt"/>
          <a:ea typeface="+mn-ea"/>
          <a:cs typeface="+mn-cs"/>
        </a:defRPr>
      </a:lvl8pPr>
      <a:lvl9pPr marL="2450592" algn="l" defTabSz="612648" rtl="0" eaLnBrk="1" latinLnBrk="0" hangingPunct="1">
        <a:defRPr sz="120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1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86" y="960425"/>
            <a:ext cx="2917808" cy="22888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388" y="960425"/>
            <a:ext cx="2917808" cy="228885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388" y="3733478"/>
            <a:ext cx="2917808" cy="2288859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3136288" y="583461"/>
            <a:ext cx="290590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64287" y="583461"/>
            <a:ext cx="291931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3143836" y="69838"/>
            <a:ext cx="289836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2200" dirty="0">
                <a:latin typeface="Arial" panose="020B0604020202020204" pitchFamily="34" charset="0"/>
                <a:cs typeface="Arial" panose="020B0604020202020204" pitchFamily="34" charset="0"/>
              </a:rPr>
              <a:t>LPHN2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71834" y="69838"/>
            <a:ext cx="291176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2200" dirty="0">
                <a:latin typeface="Arial" panose="020B0604020202020204" pitchFamily="34" charset="0"/>
                <a:cs typeface="Arial" panose="020B0604020202020204" pitchFamily="34" charset="0"/>
              </a:rPr>
              <a:t>LPHN1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3143837" y="3354922"/>
            <a:ext cx="290590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71835" y="3354922"/>
            <a:ext cx="291931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64287" y="6143388"/>
            <a:ext cx="597790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Yu Mincho" panose="02020400000000000000" pitchFamily="18" charset="-128"/>
              </a:rPr>
              <a:t>Figure S2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Yu Mincho" panose="02020400000000000000" pitchFamily="18" charset="-128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Immunohistochemistry of LPHN1 and LPHN2 in bladder tissue microarray. Representative images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show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moderate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immunoreactivity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 in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the majority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of normal-appearing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urothelial cells or urothelial tumor cells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(</a:t>
            </a:r>
            <a:r>
              <a:rPr lang="en-US" sz="1200" i="1" dirty="0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i.e.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immunoreactive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score 8; also see section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2.9).</a:t>
            </a:r>
            <a:endParaRPr lang="en-US" sz="1200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9940291"/>
              </p:ext>
            </p:extLst>
          </p:nvPr>
        </p:nvGraphicFramePr>
        <p:xfrm>
          <a:off x="71834" y="3733478"/>
          <a:ext cx="2911760" cy="22849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Image" r:id="rId6" imgW="3200400" imgH="2511360" progId="Photoshop.Image.7">
                  <p:embed/>
                </p:oleObj>
              </mc:Choice>
              <mc:Fallback>
                <p:oleObj name="Image" r:id="rId6" imgW="3200400" imgH="2511360" progId="Photoshop.Image.7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1834" y="3733478"/>
                        <a:ext cx="2911760" cy="22849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86330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56</TotalTime>
  <Words>47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MS PGothic</vt:lpstr>
      <vt:lpstr>游ゴシック</vt:lpstr>
      <vt:lpstr>Yu Mincho</vt:lpstr>
      <vt:lpstr>Arial</vt:lpstr>
      <vt:lpstr>Calibri</vt:lpstr>
      <vt:lpstr>Calibri Light</vt:lpstr>
      <vt:lpstr>Times New Roman</vt:lpstr>
      <vt:lpstr>Office Theme</vt:lpstr>
      <vt:lpstr>Image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yamoto, Hiroshi</dc:creator>
  <cp:lastModifiedBy>Miyamoto, Hiroshi</cp:lastModifiedBy>
  <cp:revision>160</cp:revision>
  <dcterms:created xsi:type="dcterms:W3CDTF">2023-12-13T21:14:31Z</dcterms:created>
  <dcterms:modified xsi:type="dcterms:W3CDTF">2026-07-07T12:04:04Z</dcterms:modified>
</cp:coreProperties>
</file>